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90"/>
    <p:restoredTop sz="91429"/>
  </p:normalViewPr>
  <p:slideViewPr>
    <p:cSldViewPr snapToGrid="0">
      <p:cViewPr>
        <p:scale>
          <a:sx n="118" d="100"/>
          <a:sy n="118" d="100"/>
        </p:scale>
        <p:origin x="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871C0B-D02B-FC42-9A08-FED47B33D03C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6331C1-C6C8-2840-882E-B0762AF06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9683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B824CB-3237-7FCE-5AA1-726D73ED77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33F560-6690-3782-36CE-7CF468E8DA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6FC7FF-C633-286B-9275-B5C7E69CC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04259F-81DC-D36B-4A45-28F9A2E3F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6736B3-DCC2-F96E-4255-28982F8D6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926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FB668-20D9-425F-1967-4A3D1B174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5380CD-6BC6-8B6B-5468-55D4794E36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384977-D713-7475-0BFD-A181A0BDA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06BB98-93CC-A122-EACA-8E06B0F86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00F11D-07DD-19E8-4AB0-F3DED8D1F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614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49EDED-9D92-35CF-877E-75D967AE8A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1A8AF-0427-0E53-0E53-07CC17DB17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835B9F-2BB3-7D8E-5BBB-DF5ED9E3E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7BBA13-5D7D-CDEF-CE28-46A36061D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661999-D6A5-D807-4EA8-561CA360C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40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F6830-DAF1-5680-484C-E6731E3CE9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B765A2-9CA2-9B5F-E03C-0BF86E4178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989080-7EA5-969E-D795-EDD346B24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9EAB5-720B-8241-74D2-6F6A1B4A4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4864DE-96DC-6804-4138-65DE38756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54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4F62E6-C1D0-6368-4D1F-56DC4B407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FD9D53-4578-2530-E32C-51E24E0EAE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27654-7E13-B896-FF7F-2CBFECC4B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3F41FF-933E-57E4-369C-4824298BA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7BCD6B-21A1-9251-64E8-57D46A459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387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B67D4-C321-01B1-88F2-8EAB82D1BF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AA5BBA-D11C-E694-D42A-5096448721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F245BE-24D1-9AA1-F0B6-4862A773C4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CD2836-5878-8527-4754-4A714CE7F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292333-CDBA-4F67-9E26-00C6FFED8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635D50-1A0B-2624-D274-1C2515FDC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487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230194-797B-B85D-627A-91854168A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A141F3-0079-2E4D-E343-F40EF4EA7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9B3B37-581F-8A7A-3A95-AC76B2115E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3A2E1F-743E-88FE-C507-D18488047B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47F97B-BD44-EF56-F25F-E5D5C092D1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3079A9-8FA9-AF93-5330-AFBBC3FA2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130332-ED74-7A04-9972-3F5AE68D1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25FB16C-AD44-96A8-B74F-5E52C95CA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10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3F006E-FC14-68B8-EF16-10D1E22B81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DDA8A0-5631-5690-EEE3-31EA50E03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D7807C-2162-5705-184B-31AE1CDF3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F836FA-1BAF-63C1-372C-8552E8CA9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769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D1BF9E-906A-5931-6182-589BC6BAF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7F331D-0AD0-8266-C441-38240B55E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DF3823-3768-C7F3-8081-252FE6574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42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70E12-E616-5614-2334-844F8AAF6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6B4F07-9D9A-8764-D94E-7BAC82C8F2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2F2002-518F-64D7-CBAE-87F910B4D5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1C1436-241E-F6F9-DCC6-5694FB79C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C06D2F-92B6-29A4-C854-B9D46460D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7BD3C7-E550-F61D-05E4-93E896464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951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7EF012-1AD7-8482-C328-0A726FED0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2D664AF-A2DC-77DC-B8B9-17C444B1A7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D6ED4A-0ED6-BA06-6888-51CD095D7B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76E8BA-259A-3E62-B9A9-A22AB35E9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E878CC-6B10-1473-DBFD-84A565697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E1A7E3-B409-382A-82F3-CA4BC7650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287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BCD3A5-5805-B277-A979-F2B7071C5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E2DD52-8790-4EA9-7A6B-03435102CA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21B016-7EF5-B882-92D3-DC5A9EDCAF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4D1B6-4AE1-4BAA-B91D-75993F7C7E16}" type="datetimeFigureOut">
              <a:rPr lang="en-US" smtClean="0"/>
              <a:t>11/1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6C1C9A-C3A8-0F6C-6DA7-F553FE39CA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32321A-3D08-270A-A689-1BB75A86B4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913D1-4CEE-4F74-ABB4-260AB101A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186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69B3E7D2-21DC-9945-B11E-6502E8D97B23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0" y="3004426"/>
            <a:ext cx="10515600" cy="1463040"/>
          </a:xfrm>
          <a:prstGeom prst="rect">
            <a:avLst/>
          </a:prstGeom>
        </p:spPr>
      </p:pic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2336ED0C-95B2-364C-8214-0DD06A9C78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4860" y="184666"/>
            <a:ext cx="3237339" cy="276825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9807F69-44AC-EE4A-BE56-F049621F34F2}"/>
              </a:ext>
            </a:extLst>
          </p:cNvPr>
          <p:cNvSpPr txBox="1"/>
          <p:nvPr/>
        </p:nvSpPr>
        <p:spPr>
          <a:xfrm>
            <a:off x="0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A166BF-D326-E747-9237-3B86D9AE3844}"/>
              </a:ext>
            </a:extLst>
          </p:cNvPr>
          <p:cNvSpPr txBox="1"/>
          <p:nvPr/>
        </p:nvSpPr>
        <p:spPr>
          <a:xfrm>
            <a:off x="4439162" y="1797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</a:t>
            </a:r>
            <a:endParaRPr lang="en-US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5590F8-F7FC-8C45-800F-9D9FE876FEB9}"/>
              </a:ext>
            </a:extLst>
          </p:cNvPr>
          <p:cNvSpPr txBox="1"/>
          <p:nvPr/>
        </p:nvSpPr>
        <p:spPr>
          <a:xfrm>
            <a:off x="28230" y="290509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C</a:t>
            </a:r>
            <a:endParaRPr lang="en-US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0A1C71C-9FE2-7E44-90A9-7F1C6DFD76C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8356" y="18463"/>
            <a:ext cx="6259286" cy="293595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7DD504C-1215-9642-B8E4-785550667BA4}"/>
              </a:ext>
            </a:extLst>
          </p:cNvPr>
          <p:cNvSpPr txBox="1"/>
          <p:nvPr/>
        </p:nvSpPr>
        <p:spPr>
          <a:xfrm>
            <a:off x="367627" y="5629709"/>
            <a:ext cx="1145674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 dirty="0"/>
              <a:t>Supplementary Fig. 1. Example of </a:t>
            </a:r>
            <a:r>
              <a:rPr lang="en-US" altLang="zh-CN" sz="1400" i="1" dirty="0" err="1"/>
              <a:t>rNMPID</a:t>
            </a:r>
            <a:r>
              <a:rPr lang="en-US" altLang="zh-CN" sz="1400" i="1" dirty="0"/>
              <a:t> database usage. </a:t>
            </a:r>
            <a:r>
              <a:rPr lang="en-US" altLang="zh-CN" sz="1400" dirty="0"/>
              <a:t>(</a:t>
            </a:r>
            <a:r>
              <a:rPr lang="en-US" altLang="zh-CN" sz="1400" b="1" dirty="0"/>
              <a:t>A</a:t>
            </a:r>
            <a:r>
              <a:rPr lang="en-US" altLang="zh-CN" sz="1400" dirty="0"/>
              <a:t>) Bar graph with data points showing the percentage of the four different rNMPs in nuclear DNA of WT and </a:t>
            </a:r>
            <a:r>
              <a:rPr lang="en-US" altLang="zh-CN" sz="1400" i="1" dirty="0"/>
              <a:t>rnh201</a:t>
            </a:r>
            <a:r>
              <a:rPr lang="en-US" altLang="zh-CN" sz="1400" dirty="0"/>
              <a:t>-null strains of </a:t>
            </a:r>
            <a:r>
              <a:rPr lang="en-US" altLang="zh-CN" sz="1400" i="1" dirty="0"/>
              <a:t>S. cerevisiae</a:t>
            </a:r>
            <a:r>
              <a:rPr lang="en-US" altLang="zh-CN" sz="1400" dirty="0"/>
              <a:t>. (</a:t>
            </a:r>
            <a:r>
              <a:rPr lang="en-US" altLang="zh-CN" sz="1400" b="1" dirty="0"/>
              <a:t>B</a:t>
            </a:r>
            <a:r>
              <a:rPr lang="en-US" altLang="zh-CN" sz="1400" dirty="0"/>
              <a:t>) Heatmap analysis with normalized frequency of each type of rNMP in nuclear DNA of WT (from RS166-to RS107) or </a:t>
            </a:r>
            <a:r>
              <a:rPr lang="en-US" altLang="zh-CN" sz="1400" i="1" dirty="0"/>
              <a:t>rnh201-</a:t>
            </a:r>
            <a:r>
              <a:rPr lang="en-US" altLang="zh-CN" sz="1400" dirty="0"/>
              <a:t>null (from RS117 to RS140) libraries of </a:t>
            </a:r>
            <a:r>
              <a:rPr lang="en-US" altLang="zh-CN" sz="1400" i="1" dirty="0"/>
              <a:t>S. cerevisiae. </a:t>
            </a:r>
            <a:r>
              <a:rPr lang="en-US" altLang="zh-CN" sz="1400" dirty="0"/>
              <a:t>(</a:t>
            </a:r>
            <a:r>
              <a:rPr lang="en-US" altLang="zh-CN" sz="1400" b="1" dirty="0"/>
              <a:t>C</a:t>
            </a:r>
            <a:r>
              <a:rPr lang="en-US" altLang="zh-CN" sz="1400" dirty="0"/>
              <a:t>) </a:t>
            </a:r>
            <a:r>
              <a:rPr lang="en-US" sz="1400" dirty="0"/>
              <a:t>Genome browser snapshot showing an </a:t>
            </a:r>
            <a:r>
              <a:rPr lang="en-US" sz="1400" dirty="0" err="1"/>
              <a:t>rG</a:t>
            </a:r>
            <a:r>
              <a:rPr lang="en-US" sz="1400" dirty="0"/>
              <a:t> hotspot within the TAAGTA-repeated sequence on the forward strand, and an </a:t>
            </a:r>
            <a:r>
              <a:rPr lang="en-US" sz="1400" dirty="0" err="1"/>
              <a:t>rC</a:t>
            </a:r>
            <a:r>
              <a:rPr lang="en-US" sz="1400" dirty="0"/>
              <a:t> hotspot in the complementary TACTTA-repeated sequence on the reverse strand in </a:t>
            </a:r>
            <a:r>
              <a:rPr lang="en-US" sz="1400" i="1" dirty="0"/>
              <a:t>S. cerevisiae </a:t>
            </a:r>
            <a:r>
              <a:rPr lang="en-US" sz="1400" dirty="0" err="1"/>
              <a:t>mtDNA</a:t>
            </a:r>
            <a:r>
              <a:rPr lang="en-US" sz="1400" dirty="0"/>
              <a:t> at the locus chrM:63583..63651 for ribose-seq library FS156.</a:t>
            </a:r>
          </a:p>
          <a:p>
            <a:endParaRPr lang="en-US" sz="1400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2B245131-DFA0-E442-82C9-51619BD7E2C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0" y="4530874"/>
            <a:ext cx="10515600" cy="1123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2885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130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Mo</dc:creator>
  <cp:lastModifiedBy>Sun, Mo</cp:lastModifiedBy>
  <cp:revision>10</cp:revision>
  <dcterms:created xsi:type="dcterms:W3CDTF">2023-11-06T03:42:41Z</dcterms:created>
  <dcterms:modified xsi:type="dcterms:W3CDTF">2023-11-10T18:30:04Z</dcterms:modified>
</cp:coreProperties>
</file>